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60" r:id="rId1"/>
  </p:sldMasterIdLst>
  <p:notesMasterIdLst>
    <p:notesMasterId r:id="rId3"/>
  </p:notesMasterIdLst>
  <p:sldIdLst>
    <p:sldId id="268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nastasia Lomova" initials="AL" lastIdx="1" clrIdx="0">
    <p:extLst>
      <p:ext uri="{19B8F6BF-5375-455C-9EA6-DF929625EA0E}">
        <p15:presenceInfo xmlns:p15="http://schemas.microsoft.com/office/powerpoint/2012/main" userId="8ecbc59e048ae0f3" providerId="Windows Live"/>
      </p:ext>
    </p:extLst>
  </p:cmAuthor>
  <p:cmAuthor id="2" name="Anastasia Kaufman" initials="ALK" lastIdx="18" clrIdx="1">
    <p:extLst>
      <p:ext uri="{19B8F6BF-5375-455C-9EA6-DF929625EA0E}">
        <p15:presenceInfo xmlns:p15="http://schemas.microsoft.com/office/powerpoint/2012/main" userId="Anastasia Kaufman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381" autoAdjust="0"/>
    <p:restoredTop sz="94660"/>
  </p:normalViewPr>
  <p:slideViewPr>
    <p:cSldViewPr snapToGrid="0">
      <p:cViewPr varScale="1">
        <p:scale>
          <a:sx n="55" d="100"/>
          <a:sy n="55" d="100"/>
        </p:scale>
        <p:origin x="1668" y="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ELIZABETH BENITEZ" userId="bfb63696475a60da" providerId="LiveId" clId="{26FDB778-58A4-4689-ABEF-C89F1F36FECA}"/>
    <pc:docChg chg="custSel modSld">
      <pc:chgData name="ELIZABETH BENITEZ" userId="bfb63696475a60da" providerId="LiveId" clId="{26FDB778-58A4-4689-ABEF-C89F1F36FECA}" dt="2020-11-07T07:46:41.602" v="308" actId="20577"/>
      <pc:docMkLst>
        <pc:docMk/>
      </pc:docMkLst>
      <pc:sldChg chg="modSp mod">
        <pc:chgData name="ELIZABETH BENITEZ" userId="bfb63696475a60da" providerId="LiveId" clId="{26FDB778-58A4-4689-ABEF-C89F1F36FECA}" dt="2020-11-07T07:46:41.602" v="308" actId="20577"/>
        <pc:sldMkLst>
          <pc:docMk/>
          <pc:sldMk cId="3328144718" sldId="268"/>
        </pc:sldMkLst>
        <pc:spChg chg="mod">
          <ac:chgData name="ELIZABETH BENITEZ" userId="bfb63696475a60da" providerId="LiveId" clId="{26FDB778-58A4-4689-ABEF-C89F1F36FECA}" dt="2020-11-07T07:45:27.562" v="51" actId="20577"/>
          <ac:spMkLst>
            <pc:docMk/>
            <pc:sldMk cId="3328144718" sldId="268"/>
            <ac:spMk id="2" creationId="{DCB1C618-8C7A-49F4-B494-66C0FA626C5F}"/>
          </ac:spMkLst>
        </pc:spChg>
        <pc:spChg chg="mod">
          <ac:chgData name="ELIZABETH BENITEZ" userId="bfb63696475a60da" providerId="LiveId" clId="{26FDB778-58A4-4689-ABEF-C89F1F36FECA}" dt="2020-11-07T07:46:41.602" v="308" actId="20577"/>
          <ac:spMkLst>
            <pc:docMk/>
            <pc:sldMk cId="3328144718" sldId="268"/>
            <ac:spMk id="7" creationId="{791D6526-6038-4CE6-8D40-755E193DA55D}"/>
          </ac:spMkLst>
        </pc:spChg>
      </pc:sldChg>
    </pc:docChg>
  </pc:docChgLst>
</pc:chgInfo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52D9018-BECE-4694-84FF-A6A06CCCEFCB}" type="datetimeFigureOut">
              <a:rPr lang="en-US" smtClean="0"/>
              <a:t>11/6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028723C-8C9E-4E92-BC57-25165E93C1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16772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17DF2B-8B62-49E5-9CF3-C82387B12A94}" type="datetimeFigureOut">
              <a:rPr lang="en-US" smtClean="0"/>
              <a:t>11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E344D-2B85-4160-AF19-525B692701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08035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17DF2B-8B62-49E5-9CF3-C82387B12A94}" type="datetimeFigureOut">
              <a:rPr lang="en-US" smtClean="0"/>
              <a:t>11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E344D-2B85-4160-AF19-525B692701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21485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17DF2B-8B62-49E5-9CF3-C82387B12A94}" type="datetimeFigureOut">
              <a:rPr lang="en-US" smtClean="0"/>
              <a:t>11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E344D-2B85-4160-AF19-525B692701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30863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17DF2B-8B62-49E5-9CF3-C82387B12A94}" type="datetimeFigureOut">
              <a:rPr lang="en-US" smtClean="0"/>
              <a:t>11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E344D-2B85-4160-AF19-525B692701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37972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17DF2B-8B62-49E5-9CF3-C82387B12A94}" type="datetimeFigureOut">
              <a:rPr lang="en-US" smtClean="0"/>
              <a:t>11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E344D-2B85-4160-AF19-525B692701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91875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17DF2B-8B62-49E5-9CF3-C82387B12A94}" type="datetimeFigureOut">
              <a:rPr lang="en-US" smtClean="0"/>
              <a:t>11/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E344D-2B85-4160-AF19-525B692701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02269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17DF2B-8B62-49E5-9CF3-C82387B12A94}" type="datetimeFigureOut">
              <a:rPr lang="en-US" smtClean="0"/>
              <a:t>11/6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E344D-2B85-4160-AF19-525B692701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57745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17DF2B-8B62-49E5-9CF3-C82387B12A94}" type="datetimeFigureOut">
              <a:rPr lang="en-US" smtClean="0"/>
              <a:t>11/6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E344D-2B85-4160-AF19-525B692701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91880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17DF2B-8B62-49E5-9CF3-C82387B12A94}" type="datetimeFigureOut">
              <a:rPr lang="en-US" smtClean="0"/>
              <a:t>11/6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E344D-2B85-4160-AF19-525B692701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832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17DF2B-8B62-49E5-9CF3-C82387B12A94}" type="datetimeFigureOut">
              <a:rPr lang="en-US" smtClean="0"/>
              <a:t>11/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E344D-2B85-4160-AF19-525B692701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00234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17DF2B-8B62-49E5-9CF3-C82387B12A94}" type="datetimeFigureOut">
              <a:rPr lang="en-US" smtClean="0"/>
              <a:t>11/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E344D-2B85-4160-AF19-525B692701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47553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17DF2B-8B62-49E5-9CF3-C82387B12A94}" type="datetimeFigureOut">
              <a:rPr lang="en-US" smtClean="0"/>
              <a:t>11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E344D-2B85-4160-AF19-525B692701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7242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>
            <a:extLst>
              <a:ext uri="{FF2B5EF4-FFF2-40B4-BE49-F238E27FC236}">
                <a16:creationId xmlns:a16="http://schemas.microsoft.com/office/drawing/2014/main" id="{DCB1C618-8C7A-49F4-B494-66C0FA626C5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8733" y="359052"/>
            <a:ext cx="4328429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4- HSPC and K562 BFP cell cycle stage distribution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91D6526-6038-4CE6-8D40-755E193DA55D}"/>
              </a:ext>
            </a:extLst>
          </p:cNvPr>
          <p:cNvSpPr txBox="1"/>
          <p:nvPr/>
        </p:nvSpPr>
        <p:spPr>
          <a:xfrm>
            <a:off x="645286" y="3466518"/>
            <a:ext cx="5414211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/>
              <a:t>Supplemental Figure 4. HSPC and K562 BFP cell cycle stages 48 hours in culture.</a:t>
            </a:r>
          </a:p>
          <a:p>
            <a:pPr algn="just"/>
            <a:r>
              <a:rPr lang="en-US" sz="1200" dirty="0"/>
              <a:t>Cell cycle stage was determined by Hoechst stain. n = 2 biological replicates. Error bars, mean± SD. </a:t>
            </a:r>
          </a:p>
        </p:txBody>
      </p:sp>
      <p:sp>
        <p:nvSpPr>
          <p:cNvPr id="4" name="Rectangle 40">
            <a:extLst>
              <a:ext uri="{FF2B5EF4-FFF2-40B4-BE49-F238E27FC236}">
                <a16:creationId xmlns:a16="http://schemas.microsoft.com/office/drawing/2014/main" id="{72AAFFD7-447C-44B9-B7DC-42BFE3B69A16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FE0D8A99-1746-4AF6-801A-3ECF1DA6847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70282069"/>
              </p:ext>
            </p:extLst>
          </p:nvPr>
        </p:nvGraphicFramePr>
        <p:xfrm>
          <a:off x="1590267" y="787078"/>
          <a:ext cx="3524250" cy="2457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8" r:id="rId3" imgW="3521767" imgH="2453009" progId="Prism8.Document">
                  <p:embed/>
                </p:oleObj>
              </mc:Choice>
              <mc:Fallback>
                <p:oleObj name="Prism 8" r:id="rId3" imgW="3521767" imgH="2453009" progId="Prism8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FE0D8A99-1746-4AF6-801A-3ECF1DA68476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590267" y="787078"/>
                        <a:ext cx="3524250" cy="245745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3281447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03</TotalTime>
  <Words>49</Words>
  <Application>Microsoft Office PowerPoint</Application>
  <PresentationFormat>Letter Paper (8.5x11 in)</PresentationFormat>
  <Paragraphs>3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8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IZABETH</dc:creator>
  <cp:lastModifiedBy>ELIZABETH BENITEZ</cp:lastModifiedBy>
  <cp:revision>41</cp:revision>
  <dcterms:created xsi:type="dcterms:W3CDTF">2020-08-22T23:18:47Z</dcterms:created>
  <dcterms:modified xsi:type="dcterms:W3CDTF">2020-11-07T07:47:06Z</dcterms:modified>
</cp:coreProperties>
</file>